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 showGuides="1">
      <p:cViewPr varScale="1">
        <p:scale>
          <a:sx n="63" d="100"/>
          <a:sy n="63" d="100"/>
        </p:scale>
        <p:origin x="732" y="6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A18C25E-8015-4AFE-A6C0-ED4B6042E52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FBFACC49-257C-4109-B83F-92319F52154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6C30F626-C1F9-43AE-B7CF-07C201BEEE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D76469-93EA-4643-B2FD-D839FBBCB6F1}" type="datetimeFigureOut">
              <a:rPr lang="en-US" smtClean="0"/>
              <a:t>5/24/2023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A301CC4B-A12C-4F3F-91AC-234D050505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F9B6810E-8CBC-49C8-B308-ACA1414870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BAE4C5-072F-416C-BD31-A69CF3021DF9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65840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1B72F2EC-A9F4-47D9-83EB-093E29AD21A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6EF869E3-D57A-4716-BBC1-0804AAC60F6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B7E182FA-B245-4314-89A3-EDEA36B81A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D76469-93EA-4643-B2FD-D839FBBCB6F1}" type="datetimeFigureOut">
              <a:rPr lang="en-US" smtClean="0"/>
              <a:t>5/24/2023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D6225A55-6239-42F8-BC83-D1BE2D9382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0A38990D-C282-4C78-9926-2561B7A772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BAE4C5-072F-416C-BD31-A69CF3021DF9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67984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354027E8-443A-4789-A331-79EED8ABC51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0476CB9B-86C1-46A4-8B80-B8B76CC8491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12B04667-6357-4A45-B8F6-7F60CF3104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D76469-93EA-4643-B2FD-D839FBBCB6F1}" type="datetimeFigureOut">
              <a:rPr lang="en-US" smtClean="0"/>
              <a:t>5/24/2023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505548AA-6C13-4C21-98D7-8604395C71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E870AB1F-02B3-421B-9805-6F37551F24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BAE4C5-072F-416C-BD31-A69CF3021DF9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05381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BF22D5C-AF02-4FF0-8605-91711DA588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D477604B-600D-4909-A4ED-AD5FFDD491A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62648FBA-0305-48B6-A42C-DB173CECE1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D76469-93EA-4643-B2FD-D839FBBCB6F1}" type="datetimeFigureOut">
              <a:rPr lang="en-US" smtClean="0"/>
              <a:t>5/24/2023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45AD09EF-0B31-469F-BC39-5655CA09E8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F515CB56-C5F3-489F-84FF-AA1DB57BC4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BAE4C5-072F-416C-BD31-A69CF3021DF9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65748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4D2075C-164F-4E40-80B9-3372856856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553E59C7-9666-41A1-811B-0536E725A26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DB07AF15-476B-4C96-AA8A-8330F55FED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D76469-93EA-4643-B2FD-D839FBBCB6F1}" type="datetimeFigureOut">
              <a:rPr lang="en-US" smtClean="0"/>
              <a:t>5/24/2023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D195C1A6-9F4F-4C48-A01E-E7B114F730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3EBFB4CB-2906-40CF-A1EA-7FFB67AEB6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BAE4C5-072F-416C-BD31-A69CF3021DF9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19432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AA3B603-D804-4F8F-A045-25D1739C6F5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A90F5FD5-FE21-42DB-AC17-B26CDA74BA3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C2AC1C26-9ACA-40B7-8901-ACFDDCE7C63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241D95D5-811A-40A6-8B23-356EF46127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D76469-93EA-4643-B2FD-D839FBBCB6F1}" type="datetimeFigureOut">
              <a:rPr lang="en-US" smtClean="0"/>
              <a:t>5/24/2023</a:t>
            </a:fld>
            <a:endParaRPr lang="en-US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18CB87C4-11B1-454A-80C7-017A3384D4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2BD12189-EE83-490F-8FD2-C88E2555E7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BAE4C5-072F-416C-BD31-A69CF3021DF9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96402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1CC0857F-CEB7-475A-8DEC-489B2F91B7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CA0F1C08-5893-4508-B523-CC265FFB808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4EE30A35-3B78-431A-8D59-47191337E5A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0E7F65D5-DC2A-4C1B-B152-904DF5F29B5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87BB835F-CC1E-4225-A9B1-A44F6429FB7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E56C57A3-7167-4617-865B-9676F58D3B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D76469-93EA-4643-B2FD-D839FBBCB6F1}" type="datetimeFigureOut">
              <a:rPr lang="en-US" smtClean="0"/>
              <a:t>5/24/2023</a:t>
            </a:fld>
            <a:endParaRPr lang="en-US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2A5DE218-AA07-4279-B8F6-4CD6689F23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7FD36823-1DE8-44CF-A122-6729AEF8F0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BAE4C5-072F-416C-BD31-A69CF3021DF9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37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F064BCDF-C816-44C6-B0A9-D1472735EEC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471CFDDF-B7CD-45BF-B72F-E8D6BED45E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D76469-93EA-4643-B2FD-D839FBBCB6F1}" type="datetimeFigureOut">
              <a:rPr lang="en-US" smtClean="0"/>
              <a:t>5/24/2023</a:t>
            </a:fld>
            <a:endParaRPr lang="en-US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22D3DCBF-6619-4058-BBF3-452342DD84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6440F50B-5C76-4519-AC56-41F83CF5F9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BAE4C5-072F-416C-BD31-A69CF3021DF9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31993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43BC15FC-C2A0-45D3-A94A-C5AD7E4234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D76469-93EA-4643-B2FD-D839FBBCB6F1}" type="datetimeFigureOut">
              <a:rPr lang="en-US" smtClean="0"/>
              <a:t>5/24/2023</a:t>
            </a:fld>
            <a:endParaRPr lang="en-US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EB76AAEB-D953-4AD5-8C9F-0DF5730881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522CEB38-F856-4071-8E27-41A92E0D07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BAE4C5-072F-416C-BD31-A69CF3021DF9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98461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6A355EEE-3483-43C1-AFCC-79A243B5B6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C91849BB-EB96-4D57-88DE-1ABB8693375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8A58B73F-9691-4C9F-A34B-7B603B33F9C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0D7349AE-2D93-496D-90D0-33949346E5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D76469-93EA-4643-B2FD-D839FBBCB6F1}" type="datetimeFigureOut">
              <a:rPr lang="en-US" smtClean="0"/>
              <a:t>5/24/2023</a:t>
            </a:fld>
            <a:endParaRPr lang="en-US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F1E6F701-0F4B-4B4A-95B6-50BD5543EB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35592BBC-798D-402D-A467-0E39C785F9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BAE4C5-072F-416C-BD31-A69CF3021DF9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22631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B7326BE-8C2A-4D99-81BA-232C74A64DC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C680DAE1-B5DF-4B57-8EEB-B437CF9CE2C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673C968C-272F-433D-8625-D562F015000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492E9F3E-EF0B-4784-9568-33150B4044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D76469-93EA-4643-B2FD-D839FBBCB6F1}" type="datetimeFigureOut">
              <a:rPr lang="en-US" smtClean="0"/>
              <a:t>5/24/2023</a:t>
            </a:fld>
            <a:endParaRPr lang="en-US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24BE1A2B-4922-4C7C-A766-CA174FDE3B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7A1DFC18-E795-4E08-946A-19671C69E1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BAE4C5-072F-416C-BD31-A69CF3021DF9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82929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45094C67-9BB0-4B56-88EF-5205A43502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2B1DBFEC-6C3D-4016-ACAC-0AE6E419945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96DD2F8C-8441-4248-BF30-9F0760D4720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D76469-93EA-4643-B2FD-D839FBBCB6F1}" type="datetimeFigureOut">
              <a:rPr lang="en-US" smtClean="0"/>
              <a:t>5/24/2023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2724B355-67EF-42DC-9B68-645F446024A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A5727557-5683-444F-AC21-0C18964D531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BAE4C5-072F-416C-BD31-A69CF3021DF9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28266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ggetto 3">
            <a:extLst>
              <a:ext uri="{FF2B5EF4-FFF2-40B4-BE49-F238E27FC236}">
                <a16:creationId xmlns:a16="http://schemas.microsoft.com/office/drawing/2014/main" id="{E19415D6-B198-483F-A29C-9FAB73A1D9C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61997619"/>
              </p:ext>
            </p:extLst>
          </p:nvPr>
        </p:nvGraphicFramePr>
        <p:xfrm>
          <a:off x="3232150" y="871618"/>
          <a:ext cx="5727700" cy="589359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6" name="Prism 9" r:id="rId3" imgW="5727959" imgH="5892531" progId="Prism9.Document">
                  <p:embed/>
                </p:oleObj>
              </mc:Choice>
              <mc:Fallback>
                <p:oleObj name="Prism 9" r:id="rId3" imgW="5727959" imgH="5892531" progId="Prism9.Document">
                  <p:embed/>
                  <p:pic>
                    <p:nvPicPr>
                      <p:cNvPr id="4" name="Oggetto 3">
                        <a:extLst>
                          <a:ext uri="{FF2B5EF4-FFF2-40B4-BE49-F238E27FC236}">
                            <a16:creationId xmlns:a16="http://schemas.microsoft.com/office/drawing/2014/main" id="{F4C58758-7AE3-401F-BAE2-918690FF52A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232150" y="871618"/>
                        <a:ext cx="5727700" cy="589359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Sottotitolo 2">
            <a:extLst>
              <a:ext uri="{FF2B5EF4-FFF2-40B4-BE49-F238E27FC236}">
                <a16:creationId xmlns:a16="http://schemas.microsoft.com/office/drawing/2014/main" id="{59F8A9BE-8F70-4457-AB84-D20F4B3F2AA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410043" y="117158"/>
            <a:ext cx="11373502" cy="1030922"/>
          </a:xfrm>
        </p:spPr>
        <p:txBody>
          <a:bodyPr anchor="ctr">
            <a:normAutofit/>
          </a:bodyPr>
          <a:lstStyle/>
          <a:p>
            <a:pPr algn="l"/>
            <a:r>
              <a:rPr lang="en-US" sz="1600" b="1" dirty="0"/>
              <a:t>Figure S1. </a:t>
            </a:r>
            <a:r>
              <a:rPr lang="en-US" sz="1600" dirty="0"/>
              <a:t>Cumulative percentage of the level of external and internal BMs’ implementation as perceived farmers and advisors.</a:t>
            </a:r>
          </a:p>
        </p:txBody>
      </p:sp>
    </p:spTree>
    <p:extLst>
      <p:ext uri="{BB962C8B-B14F-4D97-AF65-F5344CB8AC3E}">
        <p14:creationId xmlns:p14="http://schemas.microsoft.com/office/powerpoint/2010/main" val="154007381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1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8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Server OLE incorporati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ema di Office</vt:lpstr>
      <vt:lpstr>GraphPad Prism 9 Project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Andrea Laconi</dc:creator>
  <cp:lastModifiedBy>Andrea Laconi</cp:lastModifiedBy>
  <cp:revision>1</cp:revision>
  <dcterms:created xsi:type="dcterms:W3CDTF">2023-05-24T15:45:29Z</dcterms:created>
  <dcterms:modified xsi:type="dcterms:W3CDTF">2023-05-24T15:45:53Z</dcterms:modified>
</cp:coreProperties>
</file>